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DC08AF-A73D-404A-A57D-D1A05692CDF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96700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3DD5A7-4241-4461-8E8E-B966773C672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CCF441-4B99-45F1-AF72-F9904118600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E70BA6-775E-4440-BFED-B67C93C183C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47535D-6590-425D-BB06-70B6EAF5CC9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756D2A-690E-4DA8-B404-7E7C16BE5DF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F93A85-1436-4D36-80F7-94B0A66952C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7E1885-0CAF-467B-9C52-1808BEA2F44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80560"/>
            <a:ext cx="582912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003026-7C3C-4B01-8060-EBCA6022B16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45B7A2-3CC5-48CB-BFD9-64EDCD2BE4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BC807D-4069-47C9-8F65-13D907CAF4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F68030-8C27-4877-B956-7450CB51B37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9024480"/>
            <a:ext cx="142884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4480"/>
            <a:ext cx="217152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9024480"/>
            <a:ext cx="142848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43199B6-2C3F-4B30-B5AE-516E5762E61C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png"/><Relationship Id="rId3" Type="http://schemas.openxmlformats.org/officeDocument/2006/relationships/image" Target="../media/image9.png"/><Relationship Id="rId4" Type="http://schemas.openxmlformats.org/officeDocument/2006/relationships/image" Target="../media/image10.png"/><Relationship Id="rId5" Type="http://schemas.openxmlformats.org/officeDocument/2006/relationships/image" Target="../media/image11.png"/><Relationship Id="rId6" Type="http://schemas.openxmlformats.org/officeDocument/2006/relationships/image" Target="../media/image12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703440" y="1533600"/>
            <a:ext cx="5486400" cy="7561080"/>
            <a:chOff x="703440" y="1533600"/>
            <a:chExt cx="5486400" cy="7561080"/>
          </a:xfrm>
        </p:grpSpPr>
        <p:sp>
          <p:nvSpPr>
            <p:cNvPr id="42" name=""/>
            <p:cNvSpPr/>
            <p:nvPr/>
          </p:nvSpPr>
          <p:spPr>
            <a:xfrm>
              <a:off x="703440" y="1536840"/>
              <a:ext cx="5486400" cy="75578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pic>
          <p:nvPicPr>
            <p:cNvPr id="43" name="" descr=""/>
            <p:cNvPicPr/>
            <p:nvPr/>
          </p:nvPicPr>
          <p:blipFill>
            <a:blip r:embed="rId1"/>
            <a:stretch/>
          </p:blipFill>
          <p:spPr>
            <a:xfrm>
              <a:off x="3544920" y="6562800"/>
              <a:ext cx="2543040" cy="2361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" descr=""/>
            <p:cNvPicPr/>
            <p:nvPr/>
          </p:nvPicPr>
          <p:blipFill>
            <a:blip r:embed="rId2"/>
            <a:stretch/>
          </p:blipFill>
          <p:spPr>
            <a:xfrm>
              <a:off x="1150920" y="6562800"/>
              <a:ext cx="2543040" cy="2361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" descr=""/>
            <p:cNvPicPr/>
            <p:nvPr/>
          </p:nvPicPr>
          <p:blipFill>
            <a:blip r:embed="rId3"/>
            <a:stretch/>
          </p:blipFill>
          <p:spPr>
            <a:xfrm>
              <a:off x="1211400" y="1685880"/>
              <a:ext cx="2543040" cy="2362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6" name=""/>
            <p:cNvSpPr/>
            <p:nvPr/>
          </p:nvSpPr>
          <p:spPr>
            <a:xfrm>
              <a:off x="2142000" y="1685880"/>
              <a:ext cx="5799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NSC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" name=""/>
            <p:cNvSpPr/>
            <p:nvPr/>
          </p:nvSpPr>
          <p:spPr>
            <a:xfrm flipV="1">
              <a:off x="1241280" y="1875960"/>
              <a:ext cx="0" cy="2057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" name=""/>
            <p:cNvSpPr/>
            <p:nvPr/>
          </p:nvSpPr>
          <p:spPr>
            <a:xfrm rot="16200000">
              <a:off x="903960" y="2650320"/>
              <a:ext cx="468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CD3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1473480" y="1986120"/>
              <a:ext cx="573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41.6%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2849760" y="3392640"/>
              <a:ext cx="573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45.8%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985320" y="1533600"/>
              <a:ext cx="755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A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  spleen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2889360" y="1982880"/>
              <a:ext cx="497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2.7%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pic>
          <p:nvPicPr>
            <p:cNvPr id="53" name="" descr=""/>
            <p:cNvPicPr/>
            <p:nvPr/>
          </p:nvPicPr>
          <p:blipFill>
            <a:blip r:embed="rId4"/>
            <a:stretch/>
          </p:blipFill>
          <p:spPr>
            <a:xfrm>
              <a:off x="1135080" y="4064040"/>
              <a:ext cx="2610000" cy="2419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4" name="" descr=""/>
            <p:cNvPicPr/>
            <p:nvPr/>
          </p:nvPicPr>
          <p:blipFill>
            <a:blip r:embed="rId5"/>
            <a:stretch/>
          </p:blipFill>
          <p:spPr>
            <a:xfrm>
              <a:off x="3497400" y="4052880"/>
              <a:ext cx="2609640" cy="2419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5" name=""/>
            <p:cNvSpPr/>
            <p:nvPr/>
          </p:nvSpPr>
          <p:spPr>
            <a:xfrm flipV="1">
              <a:off x="1241280" y="4314600"/>
              <a:ext cx="0" cy="2057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" name=""/>
            <p:cNvSpPr/>
            <p:nvPr/>
          </p:nvSpPr>
          <p:spPr>
            <a:xfrm rot="16200000">
              <a:off x="829800" y="5076000"/>
              <a:ext cx="616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Thy1.2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3288960" y="6423120"/>
              <a:ext cx="511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B220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1241280" y="6372360"/>
              <a:ext cx="4648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1435320" y="4424400"/>
              <a:ext cx="459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47%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3727800" y="4422600"/>
              <a:ext cx="573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50.2%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2849760" y="5830920"/>
              <a:ext cx="573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16.3%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984960" y="3971880"/>
              <a:ext cx="1165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B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  bone marrow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2849760" y="4421160"/>
              <a:ext cx="573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32.6%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5207400" y="5830920"/>
              <a:ext cx="573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16.2%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5215320" y="4421160"/>
              <a:ext cx="573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28.9%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" name=""/>
            <p:cNvSpPr/>
            <p:nvPr/>
          </p:nvSpPr>
          <p:spPr>
            <a:xfrm flipV="1">
              <a:off x="1241280" y="6757560"/>
              <a:ext cx="0" cy="2057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" name=""/>
            <p:cNvSpPr/>
            <p:nvPr/>
          </p:nvSpPr>
          <p:spPr>
            <a:xfrm rot="16200000">
              <a:off x="903960" y="7498440"/>
              <a:ext cx="468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CD3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3288960" y="8794800"/>
              <a:ext cx="511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B220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1241280" y="8815320"/>
              <a:ext cx="4648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1435320" y="6867360"/>
              <a:ext cx="573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21.4%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3835800" y="6865920"/>
              <a:ext cx="573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19.6%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2849760" y="8273880"/>
              <a:ext cx="573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69.8%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985680" y="6486480"/>
              <a:ext cx="1265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C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  Peyer’s patchh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2921040" y="6864480"/>
              <a:ext cx="497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4.6%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5262840" y="8273880"/>
              <a:ext cx="573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69.9%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5251680" y="6864480"/>
              <a:ext cx="497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3.8%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pic>
          <p:nvPicPr>
            <p:cNvPr id="77" name="" descr=""/>
            <p:cNvPicPr/>
            <p:nvPr/>
          </p:nvPicPr>
          <p:blipFill>
            <a:blip r:embed="rId6"/>
            <a:stretch/>
          </p:blipFill>
          <p:spPr>
            <a:xfrm>
              <a:off x="3497400" y="1685880"/>
              <a:ext cx="2543040" cy="2362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8" name=""/>
            <p:cNvSpPr/>
            <p:nvPr/>
          </p:nvSpPr>
          <p:spPr>
            <a:xfrm>
              <a:off x="4166640" y="1685880"/>
              <a:ext cx="1290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EµEBER1.127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3826080" y="1984320"/>
              <a:ext cx="459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47%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5159520" y="3392640"/>
              <a:ext cx="573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42.1%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5204160" y="1982880"/>
              <a:ext cx="497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3.7%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1241280" y="3933720"/>
              <a:ext cx="4648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3288960" y="3925800"/>
              <a:ext cx="511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B220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84" name=""/>
          <p:cNvSpPr/>
          <p:nvPr/>
        </p:nvSpPr>
        <p:spPr>
          <a:xfrm>
            <a:off x="574560" y="662040"/>
            <a:ext cx="57150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</a:rPr>
              <a:t>Supplementary figure S3.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Flow cytometric analysis of surface markers of pre-phenotypic lymphoid tissues of EµEBER1 transgenic mice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5" name=""/>
          <p:cNvGrpSpPr/>
          <p:nvPr/>
        </p:nvGrpSpPr>
        <p:grpSpPr>
          <a:xfrm>
            <a:off x="533520" y="838080"/>
            <a:ext cx="5486400" cy="7467840"/>
            <a:chOff x="533520" y="838080"/>
            <a:chExt cx="5486400" cy="7467840"/>
          </a:xfrm>
        </p:grpSpPr>
        <p:pic>
          <p:nvPicPr>
            <p:cNvPr id="86" name="" descr=""/>
            <p:cNvPicPr/>
            <p:nvPr/>
          </p:nvPicPr>
          <p:blipFill>
            <a:blip r:embed="rId1"/>
            <a:stretch/>
          </p:blipFill>
          <p:spPr>
            <a:xfrm>
              <a:off x="3333600" y="3276720"/>
              <a:ext cx="2610000" cy="2419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7" name="" descr=""/>
            <p:cNvPicPr/>
            <p:nvPr/>
          </p:nvPicPr>
          <p:blipFill>
            <a:blip r:embed="rId2"/>
            <a:stretch/>
          </p:blipFill>
          <p:spPr>
            <a:xfrm>
              <a:off x="876240" y="3279600"/>
              <a:ext cx="2610000" cy="2419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8" name="" descr=""/>
            <p:cNvPicPr/>
            <p:nvPr/>
          </p:nvPicPr>
          <p:blipFill>
            <a:blip r:embed="rId3"/>
            <a:stretch/>
          </p:blipFill>
          <p:spPr>
            <a:xfrm>
              <a:off x="3332160" y="914400"/>
              <a:ext cx="2610000" cy="2419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9" name="" descr=""/>
            <p:cNvPicPr/>
            <p:nvPr/>
          </p:nvPicPr>
          <p:blipFill>
            <a:blip r:embed="rId4"/>
            <a:stretch/>
          </p:blipFill>
          <p:spPr>
            <a:xfrm>
              <a:off x="876240" y="914400"/>
              <a:ext cx="2610000" cy="2419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0" name=""/>
            <p:cNvSpPr/>
            <p:nvPr/>
          </p:nvSpPr>
          <p:spPr>
            <a:xfrm>
              <a:off x="1959120" y="914400"/>
              <a:ext cx="5356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NSC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" name=""/>
            <p:cNvSpPr/>
            <p:nvPr/>
          </p:nvSpPr>
          <p:spPr>
            <a:xfrm flipV="1">
              <a:off x="993600" y="1149120"/>
              <a:ext cx="0" cy="2057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2" name=""/>
            <p:cNvSpPr/>
            <p:nvPr/>
          </p:nvSpPr>
          <p:spPr>
            <a:xfrm rot="16200000">
              <a:off x="656280" y="1923120"/>
              <a:ext cx="468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CD3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3160440" y="3198960"/>
              <a:ext cx="468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CD5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993600" y="3206880"/>
              <a:ext cx="4648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4017600" y="914400"/>
              <a:ext cx="1290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EµEBER1.127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1133640" y="1258920"/>
              <a:ext cx="497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7.1%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3578400" y="1257480"/>
              <a:ext cx="497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7.1%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2787840" y="2665440"/>
              <a:ext cx="383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3%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620640" y="958680"/>
              <a:ext cx="29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D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2710080" y="1255680"/>
              <a:ext cx="459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10%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5124600" y="2665440"/>
              <a:ext cx="497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3.3%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5048640" y="1255680"/>
              <a:ext cx="573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11.2%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3" name=""/>
            <p:cNvSpPr/>
            <p:nvPr/>
          </p:nvSpPr>
          <p:spPr>
            <a:xfrm flipV="1">
              <a:off x="1000080" y="3511080"/>
              <a:ext cx="0" cy="2057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4" name=""/>
            <p:cNvSpPr/>
            <p:nvPr/>
          </p:nvSpPr>
          <p:spPr>
            <a:xfrm rot="16200000">
              <a:off x="641160" y="4261680"/>
              <a:ext cx="511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B220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1000080" y="5568840"/>
              <a:ext cx="4648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1140120" y="3621240"/>
              <a:ext cx="573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68.7%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3584880" y="3619440"/>
              <a:ext cx="573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64.4%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2794320" y="5027760"/>
              <a:ext cx="383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6%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636480" y="3274920"/>
              <a:ext cx="282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E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2605320" y="3618000"/>
              <a:ext cx="573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21.5%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5035680" y="5027760"/>
              <a:ext cx="573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15.6%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5054760" y="3618000"/>
              <a:ext cx="573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15.1%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pic>
          <p:nvPicPr>
            <p:cNvPr id="113" name="" descr=""/>
            <p:cNvPicPr/>
            <p:nvPr/>
          </p:nvPicPr>
          <p:blipFill>
            <a:blip r:embed="rId5"/>
            <a:stretch/>
          </p:blipFill>
          <p:spPr>
            <a:xfrm>
              <a:off x="3325680" y="5683320"/>
              <a:ext cx="2610000" cy="2419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4" name="" descr=""/>
            <p:cNvPicPr/>
            <p:nvPr/>
          </p:nvPicPr>
          <p:blipFill>
            <a:blip r:embed="rId6"/>
            <a:stretch/>
          </p:blipFill>
          <p:spPr>
            <a:xfrm>
              <a:off x="879480" y="5683320"/>
              <a:ext cx="2610000" cy="2419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5" name=""/>
            <p:cNvSpPr/>
            <p:nvPr/>
          </p:nvSpPr>
          <p:spPr>
            <a:xfrm flipV="1">
              <a:off x="993600" y="5930640"/>
              <a:ext cx="0" cy="2057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6" name=""/>
            <p:cNvSpPr/>
            <p:nvPr/>
          </p:nvSpPr>
          <p:spPr>
            <a:xfrm rot="16200000">
              <a:off x="663840" y="6704640"/>
              <a:ext cx="453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SSC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3160080" y="7980480"/>
              <a:ext cx="453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FSC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993600" y="7988400"/>
              <a:ext cx="4648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2565720" y="7446960"/>
              <a:ext cx="573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26.2%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654480" y="5694480"/>
              <a:ext cx="273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F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5029560" y="7446960"/>
              <a:ext cx="573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38.4%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1938240" y="6975360"/>
              <a:ext cx="533520" cy="53352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4348080" y="6975360"/>
              <a:ext cx="533520" cy="53352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2411280" y="7416720"/>
              <a:ext cx="152640" cy="1526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4818240" y="7424640"/>
              <a:ext cx="152280" cy="1526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3166920" y="5560920"/>
              <a:ext cx="468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CD5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533520" y="838080"/>
              <a:ext cx="5486400" cy="74678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9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10-16T15:35:40Z</dcterms:created>
  <dc:creator>Joanna B. Wilson</dc:creator>
  <dc:description/>
  <dc:language>en-US</dc:language>
  <cp:lastModifiedBy>Joanna Wilson</cp:lastModifiedBy>
  <cp:lastPrinted>2006-10-24T23:40:24Z</cp:lastPrinted>
  <dcterms:modified xsi:type="dcterms:W3CDTF">2010-01-18T16:58:33Z</dcterms:modified>
  <cp:revision>74</cp:revision>
  <dc:subject/>
  <dc:title>PowerPoint Presentation</dc:title>
</cp:coreProperties>
</file>